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28"/>
    <p:restoredTop sz="93301" autoAdjust="0"/>
  </p:normalViewPr>
  <p:slideViewPr>
    <p:cSldViewPr snapToGrid="0">
      <p:cViewPr varScale="1">
        <p:scale>
          <a:sx n="72" d="100"/>
          <a:sy n="72" d="100"/>
        </p:scale>
        <p:origin x="321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ALISA GIAMPETRUZZI" userId="7702e080-6f4f-4485-9421-b55e8bd01b74" providerId="ADAL" clId="{A07E1BE6-C162-4E29-878F-25DEAA55CA53}"/>
    <pc:docChg chg="modSld">
      <pc:chgData name="ANNALISA GIAMPETRUZZI" userId="7702e080-6f4f-4485-9421-b55e8bd01b74" providerId="ADAL" clId="{A07E1BE6-C162-4E29-878F-25DEAA55CA53}" dt="2024-08-09T14:37:34.090" v="14" actId="20577"/>
      <pc:docMkLst>
        <pc:docMk/>
      </pc:docMkLst>
      <pc:sldChg chg="modNotesTx">
        <pc:chgData name="ANNALISA GIAMPETRUZZI" userId="7702e080-6f4f-4485-9421-b55e8bd01b74" providerId="ADAL" clId="{A07E1BE6-C162-4E29-878F-25DEAA55CA53}" dt="2024-08-09T14:37:34.090" v="14" actId="20577"/>
        <pc:sldMkLst>
          <pc:docMk/>
          <pc:sldMk cId="4178351620" sldId="25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035447-8C18-47D8-BEE5-86935372F490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B1924A-03D6-4E9E-A155-99A971DA481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3684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1200" b="1" dirty="0" err="1"/>
              <a:t>Supplementary</a:t>
            </a:r>
            <a:r>
              <a:rPr lang="it-IT" sz="1200" b="1" dirty="0"/>
              <a:t> Figure 8.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nset of symptoms recorded on few </a:t>
            </a:r>
            <a:r>
              <a:rPr lang="en-GB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Xfp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inoculated replicates  16 months after vector inoculation. 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) Plant of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ellina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di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ardò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howing dieback and withering; b) Plant of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ellina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di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ardò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with severe desiccation; c) Plant of the genotype S218 with initial shoot dieback; d) Plants of the genotype S234 showing only defoliation. </a:t>
            </a:r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B1924A-03D6-4E9E-A155-99A971DA4811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11837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5607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924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91807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5885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7699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31858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7791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7860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926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3412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5744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C0FDA-F94A-4AC5-BF9E-B0EEAD1288C9}" type="datetimeFigureOut">
              <a:rPr lang="it-IT" smtClean="0"/>
              <a:t>09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39B27-FD1D-4E18-8E24-61AB39366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9245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pianta, aria aperta, terreno&#10;&#10;Descrizione generata automaticamente">
            <a:extLst>
              <a:ext uri="{FF2B5EF4-FFF2-40B4-BE49-F238E27FC236}">
                <a16:creationId xmlns:a16="http://schemas.microsoft.com/office/drawing/2014/main" id="{6628E34A-1453-4499-9069-840045EBF85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611" r="26839"/>
          <a:stretch/>
        </p:blipFill>
        <p:spPr>
          <a:xfrm>
            <a:off x="3829017" y="5171769"/>
            <a:ext cx="2876583" cy="3646539"/>
          </a:xfrm>
          <a:prstGeom prst="rect">
            <a:avLst/>
          </a:prstGeom>
        </p:spPr>
      </p:pic>
      <p:pic>
        <p:nvPicPr>
          <p:cNvPr id="5" name="Immagine 4" descr="Immagine che contiene pianta, pianta da appartamento, ramo, albero&#10;&#10;Descrizione generata automaticamente">
            <a:extLst>
              <a:ext uri="{FF2B5EF4-FFF2-40B4-BE49-F238E27FC236}">
                <a16:creationId xmlns:a16="http://schemas.microsoft.com/office/drawing/2014/main" id="{C64117B5-0B64-A38C-952D-BA7CD551E8D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11000" contras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937" t="5694" r="2264"/>
          <a:stretch/>
        </p:blipFill>
        <p:spPr>
          <a:xfrm>
            <a:off x="835551" y="5203780"/>
            <a:ext cx="2159677" cy="3647814"/>
          </a:xfrm>
          <a:prstGeom prst="rect">
            <a:avLst/>
          </a:prstGeom>
        </p:spPr>
      </p:pic>
      <p:pic>
        <p:nvPicPr>
          <p:cNvPr id="6" name="Immagine 5" descr="Immagine che contiene pianta da appartamento, vaso da fiori, pianta&#10;&#10;Descrizione generata automaticamente">
            <a:extLst>
              <a:ext uri="{FF2B5EF4-FFF2-40B4-BE49-F238E27FC236}">
                <a16:creationId xmlns:a16="http://schemas.microsoft.com/office/drawing/2014/main" id="{C7C07962-1A75-342C-02F7-AE1EC316E95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14000" contras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103" t="15278" r="5391"/>
          <a:stretch/>
        </p:blipFill>
        <p:spPr>
          <a:xfrm>
            <a:off x="946258" y="1136890"/>
            <a:ext cx="2199165" cy="3430922"/>
          </a:xfrm>
          <a:prstGeom prst="rect">
            <a:avLst/>
          </a:prstGeom>
        </p:spPr>
      </p:pic>
      <p:pic>
        <p:nvPicPr>
          <p:cNvPr id="8" name="Immagine 7" descr="Immagine che contiene muro, asta, ramo, arte&#10;&#10;Descrizione generata automaticamente">
            <a:extLst>
              <a:ext uri="{FF2B5EF4-FFF2-40B4-BE49-F238E27FC236}">
                <a16:creationId xmlns:a16="http://schemas.microsoft.com/office/drawing/2014/main" id="{F1A80D21-4560-4DAC-C1C1-85DA2E6C431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690" t="24368" r="19982" b="-1"/>
          <a:stretch/>
        </p:blipFill>
        <p:spPr>
          <a:xfrm>
            <a:off x="4171681" y="1119226"/>
            <a:ext cx="1883831" cy="3430922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1DDE9DE6-DE94-4BC2-EE89-C705197189DA}"/>
              </a:ext>
            </a:extLst>
          </p:cNvPr>
          <p:cNvSpPr txBox="1"/>
          <p:nvPr/>
        </p:nvSpPr>
        <p:spPr>
          <a:xfrm>
            <a:off x="135689" y="151362"/>
            <a:ext cx="66229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8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ptoms recorded on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f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plants 16 months (16mvpi) 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EBED46AC-EBE2-3D43-5B28-2E5C1723E3C2}"/>
              </a:ext>
            </a:extLst>
          </p:cNvPr>
          <p:cNvSpPr txBox="1"/>
          <p:nvPr/>
        </p:nvSpPr>
        <p:spPr>
          <a:xfrm>
            <a:off x="298500" y="867319"/>
            <a:ext cx="317716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it-IT" dirty="0">
                <a:cs typeface="Times New Roman"/>
              </a:rPr>
              <a:t>A</a:t>
            </a:r>
            <a:endParaRPr lang="it-IT" dirty="0">
              <a:cs typeface="Times New Roman" panose="02020603050405020304" pitchFamily="18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CC950B0F-4EBB-7244-F142-AB048E10F9DF}"/>
              </a:ext>
            </a:extLst>
          </p:cNvPr>
          <p:cNvSpPr txBox="1"/>
          <p:nvPr/>
        </p:nvSpPr>
        <p:spPr>
          <a:xfrm>
            <a:off x="3381752" y="867319"/>
            <a:ext cx="309700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it-IT" dirty="0"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49B53217-ED94-DE26-D96F-29EAE4371AE3}"/>
              </a:ext>
            </a:extLst>
          </p:cNvPr>
          <p:cNvSpPr txBox="1"/>
          <p:nvPr/>
        </p:nvSpPr>
        <p:spPr>
          <a:xfrm>
            <a:off x="298500" y="4760218"/>
            <a:ext cx="308098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it-IT" dirty="0"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68FCA09C-6FF5-75EF-6D17-ADA8FA861369}"/>
              </a:ext>
            </a:extLst>
          </p:cNvPr>
          <p:cNvSpPr txBox="1"/>
          <p:nvPr/>
        </p:nvSpPr>
        <p:spPr>
          <a:xfrm>
            <a:off x="3249303" y="4760218"/>
            <a:ext cx="327334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it-IT" dirty="0">
                <a:cs typeface="Times New Roman"/>
              </a:rPr>
              <a:t>D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58A11391-3E58-1E13-CC3F-CB7D8ADA1104}"/>
              </a:ext>
            </a:extLst>
          </p:cNvPr>
          <p:cNvSpPr txBox="1"/>
          <p:nvPr/>
        </p:nvSpPr>
        <p:spPr>
          <a:xfrm rot="16200000">
            <a:off x="-981923" y="2651548"/>
            <a:ext cx="3430921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ellina di </a:t>
            </a:r>
            <a:r>
              <a:rPr lang="it-IT" b="1" dirty="0">
                <a:solidFill>
                  <a:prstClr val="black"/>
                </a:solidFill>
                <a:latin typeface="Calibri" panose="020F0502020204030204"/>
              </a:rPr>
              <a:t>N</a:t>
            </a:r>
            <a:r>
              <a:rPr kumimoji="0" lang="it-IT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dò</a:t>
            </a:r>
            <a:r>
              <a:rPr kumimoji="0" lang="it-IT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97250BE9-DFB4-D6DF-F82E-D3F99A37ADC2}"/>
              </a:ext>
            </a:extLst>
          </p:cNvPr>
          <p:cNvSpPr txBox="1"/>
          <p:nvPr/>
        </p:nvSpPr>
        <p:spPr>
          <a:xfrm rot="16200000">
            <a:off x="-1227148" y="6818467"/>
            <a:ext cx="3620725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218 (Leccino X Cellina di </a:t>
            </a:r>
            <a:r>
              <a:rPr kumimoji="0" lang="it-IT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N.ardò</a:t>
            </a:r>
            <a:r>
              <a:rPr kumimoji="0" lang="it-IT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)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97BBA30F-6202-E71E-DBE6-8A5CE428A46E}"/>
              </a:ext>
            </a:extLst>
          </p:cNvPr>
          <p:cNvSpPr txBox="1"/>
          <p:nvPr/>
        </p:nvSpPr>
        <p:spPr>
          <a:xfrm rot="16200000">
            <a:off x="1755948" y="6818358"/>
            <a:ext cx="3620940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234 (Leccino X </a:t>
            </a:r>
            <a:r>
              <a:rPr kumimoji="0" lang="it-IT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Ogliarola</a:t>
            </a:r>
            <a:r>
              <a:rPr kumimoji="0" lang="it-IT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s.)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EEACE427-3B86-D503-57E7-C2F6AE07DFDB}"/>
              </a:ext>
            </a:extLst>
          </p:cNvPr>
          <p:cNvSpPr txBox="1"/>
          <p:nvPr/>
        </p:nvSpPr>
        <p:spPr>
          <a:xfrm rot="16200000">
            <a:off x="2220290" y="2651548"/>
            <a:ext cx="3430921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ellina di Nardò  </a:t>
            </a:r>
          </a:p>
        </p:txBody>
      </p:sp>
      <p:cxnSp>
        <p:nvCxnSpPr>
          <p:cNvPr id="17" name="Connettore 2 16">
            <a:extLst>
              <a:ext uri="{FF2B5EF4-FFF2-40B4-BE49-F238E27FC236}">
                <a16:creationId xmlns:a16="http://schemas.microsoft.com/office/drawing/2014/main" id="{F6CC1FCA-1CCB-F5FB-9E78-F6F239C5F1F0}"/>
              </a:ext>
            </a:extLst>
          </p:cNvPr>
          <p:cNvCxnSpPr>
            <a:cxnSpLocks/>
          </p:cNvCxnSpPr>
          <p:nvPr/>
        </p:nvCxnSpPr>
        <p:spPr>
          <a:xfrm>
            <a:off x="1160585" y="1798726"/>
            <a:ext cx="228600" cy="79130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8" name="Connettore 2 27">
            <a:extLst>
              <a:ext uri="{FF2B5EF4-FFF2-40B4-BE49-F238E27FC236}">
                <a16:creationId xmlns:a16="http://schemas.microsoft.com/office/drawing/2014/main" id="{D57D7059-8C4A-6EE2-E863-3539DBD4CE72}"/>
              </a:ext>
            </a:extLst>
          </p:cNvPr>
          <p:cNvCxnSpPr>
            <a:cxnSpLocks/>
          </p:cNvCxnSpPr>
          <p:nvPr/>
        </p:nvCxnSpPr>
        <p:spPr>
          <a:xfrm flipH="1">
            <a:off x="2831123" y="2194380"/>
            <a:ext cx="217779" cy="64030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1" name="Connettore 2 30">
            <a:extLst>
              <a:ext uri="{FF2B5EF4-FFF2-40B4-BE49-F238E27FC236}">
                <a16:creationId xmlns:a16="http://schemas.microsoft.com/office/drawing/2014/main" id="{986FA119-517F-09BF-0963-3EE4909F4F2B}"/>
              </a:ext>
            </a:extLst>
          </p:cNvPr>
          <p:cNvCxnSpPr>
            <a:cxnSpLocks/>
          </p:cNvCxnSpPr>
          <p:nvPr/>
        </p:nvCxnSpPr>
        <p:spPr>
          <a:xfrm flipV="1">
            <a:off x="946258" y="5554440"/>
            <a:ext cx="208147" cy="65802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7" name="Connettore 2 36">
            <a:extLst>
              <a:ext uri="{FF2B5EF4-FFF2-40B4-BE49-F238E27FC236}">
                <a16:creationId xmlns:a16="http://schemas.microsoft.com/office/drawing/2014/main" id="{00B2085F-82A0-06C2-8D33-FD12C9E876F1}"/>
              </a:ext>
            </a:extLst>
          </p:cNvPr>
          <p:cNvCxnSpPr>
            <a:cxnSpLocks/>
          </p:cNvCxnSpPr>
          <p:nvPr/>
        </p:nvCxnSpPr>
        <p:spPr>
          <a:xfrm>
            <a:off x="5097890" y="5425486"/>
            <a:ext cx="634695" cy="25944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783516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051</TotalTime>
  <Words>107</Words>
  <Application>Microsoft Office PowerPoint</Application>
  <PresentationFormat>A4 (21x29,7 cm)</PresentationFormat>
  <Paragraphs>11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NALISA GIAMPETRUZZI</dc:creator>
  <cp:lastModifiedBy>ANNALISA GIAMPETRUZZI</cp:lastModifiedBy>
  <cp:revision>31</cp:revision>
  <dcterms:created xsi:type="dcterms:W3CDTF">2024-01-29T16:20:00Z</dcterms:created>
  <dcterms:modified xsi:type="dcterms:W3CDTF">2024-08-09T14:37:40Z</dcterms:modified>
</cp:coreProperties>
</file>